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931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C521E-B18D-49F7-8C94-25F45D58A544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6F63B-500F-4B87-A40F-7E4C0D782E6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C521E-B18D-49F7-8C94-25F45D58A544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6F63B-500F-4B87-A40F-7E4C0D782E6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C521E-B18D-49F7-8C94-25F45D58A544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6F63B-500F-4B87-A40F-7E4C0D782E6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C521E-B18D-49F7-8C94-25F45D58A544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6F63B-500F-4B87-A40F-7E4C0D782E6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C521E-B18D-49F7-8C94-25F45D58A544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6F63B-500F-4B87-A40F-7E4C0D782E6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C521E-B18D-49F7-8C94-25F45D58A544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6F63B-500F-4B87-A40F-7E4C0D782E6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C521E-B18D-49F7-8C94-25F45D58A544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6F63B-500F-4B87-A40F-7E4C0D782E6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C521E-B18D-49F7-8C94-25F45D58A544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6F63B-500F-4B87-A40F-7E4C0D782E6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C521E-B18D-49F7-8C94-25F45D58A544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6F63B-500F-4B87-A40F-7E4C0D782E6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C521E-B18D-49F7-8C94-25F45D58A544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6F63B-500F-4B87-A40F-7E4C0D782E6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C521E-B18D-49F7-8C94-25F45D58A544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6F63B-500F-4B87-A40F-7E4C0D782E6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5C521E-B18D-49F7-8C94-25F45D58A544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06F63B-500F-4B87-A40F-7E4C0D782E6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03649" y="1"/>
            <a:ext cx="6008044" cy="5589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ZoneTexte 4"/>
          <p:cNvSpPr txBox="1"/>
          <p:nvPr/>
        </p:nvSpPr>
        <p:spPr>
          <a:xfrm>
            <a:off x="72008" y="5685055"/>
            <a:ext cx="903649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Additional file </a:t>
            </a:r>
            <a:r>
              <a:rPr lang="en-US" sz="1200" b="1" dirty="0" smtClean="0"/>
              <a:t>9:</a:t>
            </a:r>
            <a:r>
              <a:rPr lang="en-US" sz="1200" dirty="0" smtClean="0"/>
              <a:t> </a:t>
            </a:r>
            <a:r>
              <a:rPr lang="en-US" sz="1200" b="1" dirty="0"/>
              <a:t>Global effect of metal treatment on the regulation of genes as classified by COG functional categories</a:t>
            </a:r>
            <a:r>
              <a:rPr lang="en-US" sz="1200" dirty="0"/>
              <a:t>. Box plots representing the distributions of the log 2-transformed ratios </a:t>
            </a:r>
            <a:r>
              <a:rPr lang="en-US" sz="1200" dirty="0" smtClean="0"/>
              <a:t>of </a:t>
            </a:r>
            <a:r>
              <a:rPr lang="en-US" sz="1200" dirty="0"/>
              <a:t>read numbers from the metal treatments </a:t>
            </a:r>
            <a:r>
              <a:rPr lang="en-US" sz="1200" i="1" dirty="0"/>
              <a:t>per</a:t>
            </a:r>
            <a:r>
              <a:rPr lang="en-US" sz="1200" dirty="0"/>
              <a:t> read numbers from control treatments, for CDS assigned to COG classes C to </a:t>
            </a:r>
            <a:r>
              <a:rPr lang="en-US" sz="1200" dirty="0" smtClean="0"/>
              <a:t>V (indicated at the bottom of each graph), </a:t>
            </a:r>
            <a:r>
              <a:rPr lang="en-US" sz="1200" dirty="0"/>
              <a:t>for isolate STM 2683 (A and B) or STM 4661 (C and D) upon Zinc (A and C) or Cadmium (B and D) exposure. </a:t>
            </a:r>
            <a:r>
              <a:rPr lang="en-US" sz="1200" dirty="0" smtClean="0"/>
              <a:t>When within the scale, circles </a:t>
            </a:r>
            <a:r>
              <a:rPr lang="en-US" sz="1200" dirty="0"/>
              <a:t>correspond to outliers and </a:t>
            </a:r>
            <a:r>
              <a:rPr lang="en-US" sz="1200" dirty="0" smtClean="0"/>
              <a:t>asterisks to </a:t>
            </a:r>
            <a:r>
              <a:rPr lang="en-US" sz="1200" dirty="0"/>
              <a:t>extreme </a:t>
            </a:r>
            <a:r>
              <a:rPr lang="en-US" sz="1200" dirty="0" smtClean="0"/>
              <a:t>outliers and the blue color indicate extreme values. Black lanes and red crosses within boxes correspond to the median and average values  respectively. Note that approximately 75 % of the data from class J (labeled in red)  present a negative log 2-fold change.</a:t>
            </a:r>
            <a:endParaRPr lang="fr-FR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157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RD Montpelli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LE QUERE ANTOINE</dc:creator>
  <cp:lastModifiedBy>LE QUERE ANTOINE</cp:lastModifiedBy>
  <cp:revision>3</cp:revision>
  <dcterms:created xsi:type="dcterms:W3CDTF">2012-11-13T10:09:05Z</dcterms:created>
  <dcterms:modified xsi:type="dcterms:W3CDTF">2013-03-22T16:53:59Z</dcterms:modified>
</cp:coreProperties>
</file>